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B8B7D-2F3F-4704-B215-718C4B73B5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5C427-A9EB-4D49-A0A2-169A03D791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38F03-2732-4826-9DDB-C4899517DF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AD965-A2DA-472F-9126-EFFF61A70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E355B-0CBA-40B6-B679-AAB6C1E00D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0EBAE-537A-4198-96D3-66A9790BF4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7575B-5C1B-42E3-96FC-C930A3C6A1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CE4AE-FE5D-4200-9043-D7273ECBFA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10D48-BE45-42D7-BAD1-4A0D6D9BBF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7641B-7961-4AE3-866D-4CBE922A90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5BD57-0A2C-4A6A-86AA-E6165F6CB6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CB2AA-2B75-49DE-BAA7-A0EEFE1AE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FA6B42F-1E7E-462A-9840-4A41B2CB60A8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2"/>
          <p:cNvSpPr/>
          <p:nvPr/>
        </p:nvSpPr>
        <p:spPr>
          <a:xfrm>
            <a:off x="4414680" y="168120"/>
            <a:ext cx="2305080" cy="9144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nrolled at baselin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n=19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Decisione 3"/>
          <p:cNvSpPr/>
          <p:nvPr/>
        </p:nvSpPr>
        <p:spPr>
          <a:xfrm>
            <a:off x="4014720" y="1389240"/>
            <a:ext cx="3054240" cy="1002960"/>
          </a:xfrm>
          <a:prstGeom prst="flowChartDecision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andomize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n=19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ttangolo 6"/>
          <p:cNvSpPr/>
          <p:nvPr/>
        </p:nvSpPr>
        <p:spPr>
          <a:xfrm>
            <a:off x="1886040" y="2843280"/>
            <a:ext cx="2279520" cy="957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7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ocated to th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7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“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lacebo arm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“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7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n=6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ttangolo 8"/>
          <p:cNvSpPr/>
          <p:nvPr/>
        </p:nvSpPr>
        <p:spPr>
          <a:xfrm>
            <a:off x="6789600" y="2844720"/>
            <a:ext cx="2279880" cy="957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ocated to th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“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sv500 arm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”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n=6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ttangolo 9"/>
          <p:cNvSpPr/>
          <p:nvPr/>
        </p:nvSpPr>
        <p:spPr>
          <a:xfrm>
            <a:off x="1596960" y="4133880"/>
            <a:ext cx="2524320" cy="13050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ost to follow-up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n=4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ason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dache n=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tarted insulin treatment n=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ther health issues n=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ttangolo 10"/>
          <p:cNvSpPr/>
          <p:nvPr/>
        </p:nvSpPr>
        <p:spPr>
          <a:xfrm>
            <a:off x="4351320" y="4103640"/>
            <a:ext cx="2438280" cy="133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Lost to follow-up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(n= 6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Reason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Gastritis n=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Personal problems n=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Emigrated n=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Other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 issues=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ttangolo 11"/>
          <p:cNvSpPr/>
          <p:nvPr/>
        </p:nvSpPr>
        <p:spPr>
          <a:xfrm>
            <a:off x="6892920" y="4133880"/>
            <a:ext cx="2179800" cy="13050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ost to follow-u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(n= 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ason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ersonal problems n=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migrated n=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ángulo redondeado 3"/>
          <p:cNvSpPr/>
          <p:nvPr/>
        </p:nvSpPr>
        <p:spPr>
          <a:xfrm>
            <a:off x="85680" y="436680"/>
            <a:ext cx="1384200" cy="4334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bcbcbc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500" spc="-1" strike="noStrike">
                <a:solidFill>
                  <a:srgbClr val="ffffff"/>
                </a:solidFill>
                <a:latin typeface="Calibri"/>
              </a:rPr>
              <a:t>Enrolmen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ángulo redondeado 3"/>
          <p:cNvSpPr/>
          <p:nvPr/>
        </p:nvSpPr>
        <p:spPr>
          <a:xfrm>
            <a:off x="85680" y="3078000"/>
            <a:ext cx="1384200" cy="4334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bcbcbc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500" spc="-1" strike="noStrike">
                <a:solidFill>
                  <a:srgbClr val="ffffff"/>
                </a:solidFill>
                <a:latin typeface="Calibri"/>
              </a:rPr>
              <a:t>Allocation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ángulo redondeado 3"/>
          <p:cNvSpPr/>
          <p:nvPr/>
        </p:nvSpPr>
        <p:spPr>
          <a:xfrm>
            <a:off x="68400" y="4519440"/>
            <a:ext cx="1384200" cy="4334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bcbcbc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500" spc="-1" strike="noStrike">
                <a:solidFill>
                  <a:srgbClr val="ffffff"/>
                </a:solidFill>
                <a:latin typeface="Calibri"/>
              </a:rPr>
              <a:t>Follow-up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ángulo redondeado 3"/>
          <p:cNvSpPr/>
          <p:nvPr/>
        </p:nvSpPr>
        <p:spPr>
          <a:xfrm>
            <a:off x="68400" y="5987880"/>
            <a:ext cx="1384200" cy="4334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bcbcbc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500" spc="-1" strike="noStrike">
                <a:solidFill>
                  <a:srgbClr val="ffffff"/>
                </a:solidFill>
                <a:latin typeface="Calibri"/>
              </a:rPr>
              <a:t>Analysis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ttangolo 16"/>
          <p:cNvSpPr/>
          <p:nvPr/>
        </p:nvSpPr>
        <p:spPr>
          <a:xfrm>
            <a:off x="1862280" y="5789520"/>
            <a:ext cx="2179440" cy="9018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alyze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=5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ttangolo 19"/>
          <p:cNvSpPr/>
          <p:nvPr/>
        </p:nvSpPr>
        <p:spPr>
          <a:xfrm>
            <a:off x="4454640" y="5786280"/>
            <a:ext cx="2179440" cy="9018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alyze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=5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ttangolo 20"/>
          <p:cNvSpPr/>
          <p:nvPr/>
        </p:nvSpPr>
        <p:spPr>
          <a:xfrm>
            <a:off x="6892920" y="5789520"/>
            <a:ext cx="2179800" cy="9018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alyze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=6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onnettore 1 4"/>
          <p:cNvSpPr/>
          <p:nvPr/>
        </p:nvSpPr>
        <p:spPr>
          <a:xfrm flipH="1">
            <a:off x="3025440" y="2392200"/>
            <a:ext cx="2516040" cy="4510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onnettore 1 35"/>
          <p:cNvSpPr/>
          <p:nvPr/>
        </p:nvSpPr>
        <p:spPr>
          <a:xfrm>
            <a:off x="5541840" y="2392200"/>
            <a:ext cx="2387880" cy="452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onnettore 1 27"/>
          <p:cNvSpPr/>
          <p:nvPr/>
        </p:nvSpPr>
        <p:spPr>
          <a:xfrm>
            <a:off x="5541840" y="2392200"/>
            <a:ext cx="25560" cy="685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ttangolo 7"/>
          <p:cNvSpPr/>
          <p:nvPr/>
        </p:nvSpPr>
        <p:spPr>
          <a:xfrm>
            <a:off x="4351320" y="2827440"/>
            <a:ext cx="2279520" cy="957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ocated to th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“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sv40 arm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”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n=6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onnettore 1 46"/>
          <p:cNvSpPr/>
          <p:nvPr/>
        </p:nvSpPr>
        <p:spPr>
          <a:xfrm>
            <a:off x="3025800" y="380052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onnettore 1 50"/>
          <p:cNvSpPr/>
          <p:nvPr/>
        </p:nvSpPr>
        <p:spPr>
          <a:xfrm>
            <a:off x="7988400" y="545616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onnettore 1 51"/>
          <p:cNvSpPr/>
          <p:nvPr/>
        </p:nvSpPr>
        <p:spPr>
          <a:xfrm>
            <a:off x="5605560" y="543888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onnettore 1 52"/>
          <p:cNvSpPr/>
          <p:nvPr/>
        </p:nvSpPr>
        <p:spPr>
          <a:xfrm>
            <a:off x="3059280" y="545616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onnettore 1 53"/>
          <p:cNvSpPr/>
          <p:nvPr/>
        </p:nvSpPr>
        <p:spPr>
          <a:xfrm>
            <a:off x="7988400" y="380052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onnettore 1 54"/>
          <p:cNvSpPr/>
          <p:nvPr/>
        </p:nvSpPr>
        <p:spPr>
          <a:xfrm>
            <a:off x="5591160" y="377028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onnettore 1 55"/>
          <p:cNvSpPr/>
          <p:nvPr/>
        </p:nvSpPr>
        <p:spPr>
          <a:xfrm>
            <a:off x="5551560" y="1082520"/>
            <a:ext cx="0" cy="333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6T17:19:21Z</dcterms:created>
  <dc:creator>Anna Hernández Aguilera</dc:creator>
  <dc:description/>
  <dc:language>en-US</dc:language>
  <cp:lastModifiedBy>sbo</cp:lastModifiedBy>
  <dcterms:modified xsi:type="dcterms:W3CDTF">2018-02-10T16:17:14Z</dcterms:modified>
  <cp:revision>23</cp:revision>
  <dc:subject/>
  <dc:title>Presentación de PowerPoint</dc:title>
</cp:coreProperties>
</file>